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797675" cy="9929813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3" autoAdjust="0"/>
    <p:restoredTop sz="94660"/>
  </p:normalViewPr>
  <p:slideViewPr>
    <p:cSldViewPr snapToGrid="0">
      <p:cViewPr>
        <p:scale>
          <a:sx n="100" d="100"/>
          <a:sy n="100" d="100"/>
        </p:scale>
        <p:origin x="944" y="4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27CB9-9F5D-42EB-97B4-464BD45D3893}" type="datetimeFigureOut">
              <a:rPr lang="ko-KR" altLang="en-US" smtClean="0"/>
              <a:t>2018. 7. 20.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D1046-EEA6-4C8C-8AAD-96D3BCC3847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559680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27CB9-9F5D-42EB-97B4-464BD45D3893}" type="datetimeFigureOut">
              <a:rPr lang="ko-KR" altLang="en-US" smtClean="0"/>
              <a:t>2018. 7. 20.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D1046-EEA6-4C8C-8AAD-96D3BCC3847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015360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27CB9-9F5D-42EB-97B4-464BD45D3893}" type="datetimeFigureOut">
              <a:rPr lang="ko-KR" altLang="en-US" smtClean="0"/>
              <a:t>2018. 7. 20.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D1046-EEA6-4C8C-8AAD-96D3BCC3847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948801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27CB9-9F5D-42EB-97B4-464BD45D3893}" type="datetimeFigureOut">
              <a:rPr lang="ko-KR" altLang="en-US" smtClean="0"/>
              <a:t>2018. 7. 20.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D1046-EEA6-4C8C-8AAD-96D3BCC3847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00313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27CB9-9F5D-42EB-97B4-464BD45D3893}" type="datetimeFigureOut">
              <a:rPr lang="ko-KR" altLang="en-US" smtClean="0"/>
              <a:t>2018. 7. 20.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D1046-EEA6-4C8C-8AAD-96D3BCC3847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609764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27CB9-9F5D-42EB-97B4-464BD45D3893}" type="datetimeFigureOut">
              <a:rPr lang="ko-KR" altLang="en-US" smtClean="0"/>
              <a:t>2018. 7. 20.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D1046-EEA6-4C8C-8AAD-96D3BCC3847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471386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27CB9-9F5D-42EB-97B4-464BD45D3893}" type="datetimeFigureOut">
              <a:rPr lang="ko-KR" altLang="en-US" smtClean="0"/>
              <a:t>2018. 7. 20.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D1046-EEA6-4C8C-8AAD-96D3BCC3847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180768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27CB9-9F5D-42EB-97B4-464BD45D3893}" type="datetimeFigureOut">
              <a:rPr lang="ko-KR" altLang="en-US" smtClean="0"/>
              <a:t>2018. 7. 20.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D1046-EEA6-4C8C-8AAD-96D3BCC3847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545389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27CB9-9F5D-42EB-97B4-464BD45D3893}" type="datetimeFigureOut">
              <a:rPr lang="ko-KR" altLang="en-US" smtClean="0"/>
              <a:t>2018. 7. 20.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D1046-EEA6-4C8C-8AAD-96D3BCC3847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112963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27CB9-9F5D-42EB-97B4-464BD45D3893}" type="datetimeFigureOut">
              <a:rPr lang="ko-KR" altLang="en-US" smtClean="0"/>
              <a:t>2018. 7. 20.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D1046-EEA6-4C8C-8AAD-96D3BCC3847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365138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27CB9-9F5D-42EB-97B4-464BD45D3893}" type="datetimeFigureOut">
              <a:rPr lang="ko-KR" altLang="en-US" smtClean="0"/>
              <a:t>2018. 7. 20.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D1046-EEA6-4C8C-8AAD-96D3BCC3847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302070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327CB9-9F5D-42EB-97B4-464BD45D3893}" type="datetimeFigureOut">
              <a:rPr lang="ko-KR" altLang="en-US" smtClean="0"/>
              <a:t>2018. 7. 20.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FD1046-EEA6-4C8C-8AAD-96D3BCC3847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466354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0" Type="http://schemas.openxmlformats.org/officeDocument/2006/relationships/image" Target="../media/image9.png"/><Relationship Id="rId11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그룹 13"/>
          <p:cNvGrpSpPr/>
          <p:nvPr/>
        </p:nvGrpSpPr>
        <p:grpSpPr>
          <a:xfrm>
            <a:off x="33969" y="880820"/>
            <a:ext cx="5796951" cy="5332531"/>
            <a:chOff x="130785" y="0"/>
            <a:chExt cx="6858594" cy="6085203"/>
          </a:xfrm>
        </p:grpSpPr>
        <p:pic>
          <p:nvPicPr>
            <p:cNvPr id="11" name="그림 10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30785" y="567845"/>
              <a:ext cx="6858594" cy="5517358"/>
            </a:xfrm>
            <a:prstGeom prst="rect">
              <a:avLst/>
            </a:prstGeom>
          </p:spPr>
        </p:pic>
        <p:sp>
          <p:nvSpPr>
            <p:cNvPr id="5" name="TextBox 4"/>
            <p:cNvSpPr txBox="1"/>
            <p:nvPr/>
          </p:nvSpPr>
          <p:spPr>
            <a:xfrm>
              <a:off x="2375238" y="2975610"/>
              <a:ext cx="2448910" cy="351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. baumannii </a:t>
              </a:r>
              <a:r>
                <a:rPr lang="en-US" altLang="ko-KR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U202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2" name="그룹 11"/>
            <p:cNvGrpSpPr/>
            <p:nvPr/>
          </p:nvGrpSpPr>
          <p:grpSpPr>
            <a:xfrm>
              <a:off x="4708315" y="0"/>
              <a:ext cx="2281064" cy="830997"/>
              <a:chOff x="7921109" y="1748853"/>
              <a:chExt cx="2281064" cy="830997"/>
            </a:xfrm>
          </p:grpSpPr>
          <p:pic>
            <p:nvPicPr>
              <p:cNvPr id="9" name="그림 8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7921109" y="1799494"/>
                <a:ext cx="231668" cy="780356"/>
              </a:xfrm>
              <a:prstGeom prst="rect">
                <a:avLst/>
              </a:prstGeom>
            </p:spPr>
          </p:pic>
          <p:sp>
            <p:nvSpPr>
              <p:cNvPr id="10" name="TextBox 9"/>
              <p:cNvSpPr txBox="1"/>
              <p:nvPr/>
            </p:nvSpPr>
            <p:spPr>
              <a:xfrm>
                <a:off x="8091577" y="1748853"/>
                <a:ext cx="2110596" cy="80780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DS</a:t>
                </a:r>
              </a:p>
              <a:p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hage region</a:t>
                </a:r>
              </a:p>
              <a:p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rotein identified in OMV</a:t>
                </a:r>
                <a:r>
                  <a:rPr lang="en-US" altLang="ko-KR" sz="1000" baseline="-25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B</a:t>
                </a:r>
              </a:p>
              <a:p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rotein identified in OMV</a:t>
                </a:r>
                <a:r>
                  <a:rPr lang="en-US" altLang="ko-KR" sz="1000" baseline="-25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IM</a:t>
                </a:r>
                <a:endParaRPr lang="ko-KR" altLang="en-US" sz="1000" baseline="-25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pic>
        <p:nvPicPr>
          <p:cNvPr id="16" name="그림 15"/>
          <p:cNvPicPr preferRelativeResize="0"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66175" y="1299920"/>
            <a:ext cx="2628000" cy="1044000"/>
          </a:xfrm>
          <a:prstGeom prst="rect">
            <a:avLst/>
          </a:prstGeom>
        </p:spPr>
      </p:pic>
      <p:pic>
        <p:nvPicPr>
          <p:cNvPr id="17" name="그림 16"/>
          <p:cNvPicPr preferRelativeResize="0">
            <a:picLocks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66175" y="2729430"/>
            <a:ext cx="2628000" cy="1044000"/>
          </a:xfrm>
          <a:prstGeom prst="rect">
            <a:avLst/>
          </a:prstGeom>
        </p:spPr>
      </p:pic>
      <p:pic>
        <p:nvPicPr>
          <p:cNvPr id="18" name="그림 17"/>
          <p:cNvPicPr preferRelativeResize="0">
            <a:picLocks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66175" y="4158940"/>
            <a:ext cx="2628000" cy="1044000"/>
          </a:xfrm>
          <a:prstGeom prst="rect">
            <a:avLst/>
          </a:prstGeom>
        </p:spPr>
      </p:pic>
      <p:pic>
        <p:nvPicPr>
          <p:cNvPr id="19" name="그림 18"/>
          <p:cNvPicPr preferRelativeResize="0">
            <a:picLocks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66175" y="5588451"/>
            <a:ext cx="2628000" cy="1044000"/>
          </a:xfrm>
          <a:prstGeom prst="rect">
            <a:avLst/>
          </a:prstGeom>
        </p:spPr>
      </p:pic>
      <p:pic>
        <p:nvPicPr>
          <p:cNvPr id="20" name="그림 19"/>
          <p:cNvPicPr preferRelativeResize="0">
            <a:picLocks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50416" y="1299920"/>
            <a:ext cx="2628000" cy="1044000"/>
          </a:xfrm>
          <a:prstGeom prst="rect">
            <a:avLst/>
          </a:prstGeom>
        </p:spPr>
      </p:pic>
      <p:pic>
        <p:nvPicPr>
          <p:cNvPr id="21" name="그림 20"/>
          <p:cNvPicPr preferRelativeResize="0">
            <a:picLocks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50417" y="2733553"/>
            <a:ext cx="2628000" cy="1044000"/>
          </a:xfrm>
          <a:prstGeom prst="rect">
            <a:avLst/>
          </a:prstGeom>
        </p:spPr>
      </p:pic>
      <p:pic>
        <p:nvPicPr>
          <p:cNvPr id="22" name="그림 21"/>
          <p:cNvPicPr preferRelativeResize="0">
            <a:picLocks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50416" y="4167186"/>
            <a:ext cx="2628000" cy="1044000"/>
          </a:xfrm>
          <a:prstGeom prst="rect">
            <a:avLst/>
          </a:prstGeom>
        </p:spPr>
      </p:pic>
      <p:pic>
        <p:nvPicPr>
          <p:cNvPr id="23" name="그림 22"/>
          <p:cNvPicPr preferRelativeResize="0">
            <a:picLocks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50416" y="5600820"/>
            <a:ext cx="2628000" cy="1044000"/>
          </a:xfrm>
          <a:prstGeom prst="rect">
            <a:avLst/>
          </a:prstGeom>
        </p:spPr>
      </p:pic>
      <p:sp>
        <p:nvSpPr>
          <p:cNvPr id="24" name="TextBox 23"/>
          <p:cNvSpPr txBox="1"/>
          <p:nvPr/>
        </p:nvSpPr>
        <p:spPr>
          <a:xfrm>
            <a:off x="6019863" y="3857100"/>
            <a:ext cx="15903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hage03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6019863" y="1022920"/>
            <a:ext cx="15903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hage01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6019863" y="2440010"/>
            <a:ext cx="15903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hage02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6019863" y="5274191"/>
            <a:ext cx="15903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hage04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9046575" y="1022921"/>
            <a:ext cx="15903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hage05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9046575" y="2439642"/>
            <a:ext cx="15903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hage06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9046575" y="3856363"/>
            <a:ext cx="15903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hage07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9046575" y="5273085"/>
            <a:ext cx="15903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hage08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160969" y="182808"/>
            <a:ext cx="2080304" cy="281291"/>
          </a:xfrm>
          <a:prstGeom prst="rect">
            <a:avLst/>
          </a:prstGeom>
          <a:noFill/>
        </p:spPr>
        <p:txBody>
          <a:bodyPr wrap="none" lIns="69655" tIns="34828" rIns="69655" bIns="34828" rtlCol="0">
            <a:spAutoFit/>
          </a:bodyPr>
          <a:lstStyle/>
          <a:p>
            <a:r>
              <a:rPr lang="en-US" altLang="ko-KR" sz="1371" dirty="0" smtClean="0">
                <a:solidFill>
                  <a:schemeClr val="bg1">
                    <a:lumMod val="65000"/>
                  </a:schemeClr>
                </a:solidFill>
                <a:latin typeface="Times New Roman" pitchFamily="18" charset="0"/>
                <a:cs typeface="Times New Roman" pitchFamily="18" charset="0"/>
              </a:rPr>
              <a:t>Additional file </a:t>
            </a:r>
            <a:r>
              <a:rPr lang="en-US" altLang="ko-KR" sz="1371" dirty="0" smtClean="0">
                <a:solidFill>
                  <a:schemeClr val="bg1">
                    <a:lumMod val="65000"/>
                  </a:schemeClr>
                </a:solidFill>
                <a:latin typeface="Times New Roman" pitchFamily="18" charset="0"/>
                <a:cs typeface="Times New Roman" pitchFamily="18" charset="0"/>
              </a:rPr>
              <a:t>3: </a:t>
            </a:r>
            <a:r>
              <a:rPr lang="en-US" altLang="ko-KR" sz="1371" dirty="0" smtClean="0">
                <a:solidFill>
                  <a:schemeClr val="bg1">
                    <a:lumMod val="65000"/>
                  </a:schemeClr>
                </a:solidFill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ko-KR" sz="1371" dirty="0" smtClean="0">
                <a:solidFill>
                  <a:schemeClr val="bg1">
                    <a:lumMod val="65000"/>
                  </a:schemeClr>
                </a:solidFill>
                <a:latin typeface="Times New Roman" pitchFamily="18" charset="0"/>
                <a:cs typeface="Times New Roman" pitchFamily="18" charset="0"/>
              </a:rPr>
              <a:t>S2</a:t>
            </a:r>
            <a:endParaRPr lang="ko-KR" altLang="en-US" sz="1371" dirty="0">
              <a:solidFill>
                <a:schemeClr val="bg1">
                  <a:lumMod val="65000"/>
                </a:schemeClr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411481" y="611905"/>
            <a:ext cx="46481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smtClean="0"/>
              <a:t>A</a:t>
            </a:r>
            <a:endParaRPr lang="en-US" sz="2000" b="1"/>
          </a:p>
        </p:txBody>
      </p:sp>
      <p:sp>
        <p:nvSpPr>
          <p:cNvPr id="33" name="TextBox 32"/>
          <p:cNvSpPr txBox="1"/>
          <p:nvPr/>
        </p:nvSpPr>
        <p:spPr>
          <a:xfrm>
            <a:off x="6034120" y="611905"/>
            <a:ext cx="46481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9738352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6</TotalTime>
  <Words>31</Words>
  <Application>Microsoft Macintosh PowerPoint</Application>
  <PresentationFormat>Widescreen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Times New Roman</vt:lpstr>
      <vt:lpstr>맑은 고딕</vt:lpstr>
      <vt:lpstr>Arial</vt:lpstr>
      <vt:lpstr>Office 테마</vt:lpstr>
      <vt:lpstr>PowerPoint Presentation</vt:lpstr>
    </vt:vector>
  </TitlesOfParts>
  <Company/>
  <LinksUpToDate>false</LinksUpToDate>
  <SharedDoc>false</SharedDoc>
  <HyperlinksChanged>false</HyperlinksChanged>
  <AppVersion>15.0033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Lee Sang-Yeop</dc:creator>
  <cp:lastModifiedBy>Edmond C. Park</cp:lastModifiedBy>
  <cp:revision>6</cp:revision>
  <cp:lastPrinted>2018-07-19T05:42:59Z</cp:lastPrinted>
  <dcterms:created xsi:type="dcterms:W3CDTF">2018-07-19T05:36:23Z</dcterms:created>
  <dcterms:modified xsi:type="dcterms:W3CDTF">2018-07-20T04:45:04Z</dcterms:modified>
</cp:coreProperties>
</file>